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09_2176705B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8" r:id="rId2"/>
    <p:sldId id="260" r:id="rId3"/>
    <p:sldId id="268" r:id="rId4"/>
    <p:sldId id="263" r:id="rId5"/>
    <p:sldId id="270" r:id="rId6"/>
    <p:sldId id="274" r:id="rId7"/>
    <p:sldId id="271" r:id="rId8"/>
    <p:sldId id="265" r:id="rId9"/>
    <p:sldId id="272" r:id="rId10"/>
    <p:sldId id="264" r:id="rId11"/>
    <p:sldId id="273" r:id="rId12"/>
    <p:sldId id="262" r:id="rId1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6" userDrawn="1">
          <p15:clr>
            <a:srgbClr val="A4A3A4"/>
          </p15:clr>
        </p15:guide>
        <p15:guide id="2" pos="5881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EC051A8-B68C-1F62-B8D5-24BB8FDCFABC}" name="Fabio Martelli" initials="FM" userId="S::fabio.martelli@grupposandonato.it::6b433702-2f3a-4c44-9041-de02f3928f8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784" y="176"/>
      </p:cViewPr>
      <p:guideLst>
        <p:guide orient="horz" pos="1706"/>
        <p:guide pos="58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omments/modernComment_109_2176705B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2F7DC86C-605E-46AF-81F0-96447EC200D3}" authorId="{CEC051A8-B68C-1F62-B8D5-24BB8FDCFABC}" created="2024-09-17T09:43:56.481">
    <ac:txMkLst xmlns:ac="http://schemas.microsoft.com/office/drawing/2013/main/command">
      <pc:docMk xmlns:pc="http://schemas.microsoft.com/office/powerpoint/2013/main/command"/>
      <pc:sldMk xmlns:pc="http://schemas.microsoft.com/office/powerpoint/2013/main/command" cId="561410139" sldId="265"/>
      <ac:spMk id="5" creationId="{00000000-0000-0000-0000-000000000000}"/>
      <ac:txMk cp="210" len="80">
        <ac:context len="294" hash="2086603149"/>
      </ac:txMk>
    </ac:txMkLst>
    <p188:pos x="11726142" y="397649"/>
    <p188:txBody>
      <a:bodyPr/>
      <a:lstStyle/>
      <a:p>
        <a:r>
          <a:rPr lang="it-IT"/>
          <a:t>Perché non SEM come in tutto il resto del paper?</a:t>
        </a:r>
      </a:p>
    </p188:txBody>
  </p188:cm>
  <p188:cm id="{2533AAF4-0E2B-4521-931C-0D9923B265C0}" authorId="{CEC051A8-B68C-1F62-B8D5-24BB8FDCFABC}" created="2024-09-17T09:44:13.746">
    <ac:txMkLst xmlns:ac="http://schemas.microsoft.com/office/drawing/2013/main/command">
      <pc:docMk xmlns:pc="http://schemas.microsoft.com/office/powerpoint/2013/main/command"/>
      <pc:sldMk xmlns:pc="http://schemas.microsoft.com/office/powerpoint/2013/main/command" cId="561410139" sldId="265"/>
      <ac:spMk id="5" creationId="{00000000-0000-0000-0000-000000000000}"/>
      <ac:txMk cp="210" len="80">
        <ac:context len="294" hash="2086603149"/>
      </ac:txMk>
    </ac:txMkLst>
    <p188:pos x="11726142" y="397649"/>
    <p188:txBody>
      <a:bodyPr/>
      <a:lstStyle/>
      <a:p>
        <a:r>
          <a:rPr lang="it-IT"/>
          <a:t>Giusto?</a:t>
        </a:r>
      </a:p>
    </p188:txBody>
  </p188:cm>
</p188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BB7C3B-8E01-49B3-B0A7-F6DD76C689F5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020230-E157-4B7C-9300-3D435B5321B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4826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7656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1433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263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8156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3588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0905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170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6773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9347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9491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7573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57E69-6117-4193-A93C-B0551F405581}" type="datetimeFigureOut">
              <a:rPr lang="it-IT" smtClean="0"/>
              <a:t>16/05/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C65BB-4D02-4FDF-81A1-BC612BC89B2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8780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microsoft.com/office/2018/10/relationships/comments" Target="../comments/modernComment_109_2176705B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33262" y="5617388"/>
            <a:ext cx="1208809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1. </a:t>
            </a:r>
            <a:r>
              <a:rPr lang="en-GB" sz="1200" b="1" dirty="0">
                <a:latin typeface="Palatino Linotype" panose="02040502050505030304" pitchFamily="18" charset="0"/>
              </a:rPr>
              <a:t>No significant changes in miR-144-3p expression levels between no major physical symptoms (MPS) and MPS patients and between no major neuropsychological symptoms (MNS) and MNS patients. </a:t>
            </a:r>
            <a:r>
              <a:rPr lang="en-GB" sz="1200" dirty="0">
                <a:latin typeface="Palatino Linotype" panose="02040502050505030304" pitchFamily="18" charset="0"/>
              </a:rPr>
              <a:t>miR-144-3p plasma levels were measured by qPCR in patients with or without MPS (A) or MNS (B). Values are represented as log</a:t>
            </a:r>
            <a:r>
              <a:rPr lang="en-GB" sz="1200" baseline="-25000" dirty="0">
                <a:latin typeface="Palatino Linotype" panose="02040502050505030304" pitchFamily="18" charset="0"/>
              </a:rPr>
              <a:t>2</a:t>
            </a:r>
            <a:r>
              <a:rPr lang="en-GB" sz="1200" dirty="0">
                <a:latin typeface="Palatino Linotype" panose="02040502050505030304" pitchFamily="18" charset="0"/>
              </a:rPr>
              <a:t> fold changes and shown using violin plots, with dashed lines indicating the median and dotted lines denoting the second and third quartiles. Unpaired t-test (two groups) was used for statistical comparison: differences were not statistically significant. No MPS patients n = 43; MPS patients n = 48. No MNS patients n = 56; MNS patients n = 35. </a:t>
            </a:r>
          </a:p>
          <a:p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pSp>
        <p:nvGrpSpPr>
          <p:cNvPr id="7" name="Gruppo 6">
            <a:extLst>
              <a:ext uri="{FF2B5EF4-FFF2-40B4-BE49-F238E27FC236}">
                <a16:creationId xmlns:a16="http://schemas.microsoft.com/office/drawing/2014/main" id="{2E43CD1F-5FF4-B647-B84E-0175137AA7D3}"/>
              </a:ext>
            </a:extLst>
          </p:cNvPr>
          <p:cNvGrpSpPr/>
          <p:nvPr/>
        </p:nvGrpSpPr>
        <p:grpSpPr>
          <a:xfrm>
            <a:off x="33262" y="461230"/>
            <a:ext cx="11514080" cy="4927634"/>
            <a:chOff x="33262" y="461230"/>
            <a:chExt cx="11514080" cy="4927634"/>
          </a:xfrm>
        </p:grpSpPr>
        <p:sp>
          <p:nvSpPr>
            <p:cNvPr id="10" name="CasellaDiTesto 9"/>
            <p:cNvSpPr txBox="1"/>
            <p:nvPr/>
          </p:nvSpPr>
          <p:spPr>
            <a:xfrm>
              <a:off x="313217" y="461317"/>
              <a:ext cx="44069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6059580" y="461433"/>
              <a:ext cx="44069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7593018" y="461259"/>
              <a:ext cx="30653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miR-144-3p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1834463" y="461230"/>
              <a:ext cx="30653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miR-144-3p</a:t>
              </a:r>
            </a:p>
          </p:txBody>
        </p:sp>
        <p:pic>
          <p:nvPicPr>
            <p:cNvPr id="5" name="Immagine 4" descr="Immagine che contiene diagramma, linea, Carattere, Diagramma&#10;&#10;Descrizione generata automaticamente">
              <a:extLst>
                <a:ext uri="{FF2B5EF4-FFF2-40B4-BE49-F238E27FC236}">
                  <a16:creationId xmlns:a16="http://schemas.microsoft.com/office/drawing/2014/main" id="{F777A965-214A-1D49-B6A2-EF1ED987E3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62" y="922895"/>
              <a:ext cx="11514080" cy="446596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857276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ella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7993374"/>
              </p:ext>
            </p:extLst>
          </p:nvPr>
        </p:nvGraphicFramePr>
        <p:xfrm>
          <a:off x="2462645" y="1132612"/>
          <a:ext cx="7720446" cy="4516507"/>
        </p:xfrm>
        <a:graphic>
          <a:graphicData uri="http://schemas.openxmlformats.org/drawingml/2006/table">
            <a:tbl>
              <a:tblPr/>
              <a:tblGrid>
                <a:gridCol w="34538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6656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1387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S1: primer sequenc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419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imer</a:t>
                      </a:r>
                      <a:r>
                        <a:rPr lang="en-GB" sz="1200" b="1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pairs</a:t>
                      </a:r>
                      <a:endParaRPr lang="en-GB" sz="12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16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G18-2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: GTGGGCTATATTAAGTGGGAA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16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: TCTTCTCTATATCTCAAGGTATG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16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G18 long isoform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: AGGTACTGGTGGTGTGGCT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16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: GGTCATCATCAGTGGGGCT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16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ncCEACAM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: CAAGTATCTCTTCTCAACGGAA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16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: ATCATTATTCACGCATCCACA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16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F1-AS1-2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: GTCCATGCTATGACCATCTCC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16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: ACACGAGTTAAGGCACATTCA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16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F1-AS1 multiple isoform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: CACAAGAACAGAGGAGCGG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16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: AGCACATCCCCCAACATT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16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F1-AS1-2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: AAGGACGAGAGAAAAGCA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16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: CACACAAAGGGGAAGAC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16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F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: AGAACACCCCGATGACGG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1616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: GAGGGTCCCTTGTTGTAGAG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16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: GATCGCTGTGATCGTCACTTGACA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6419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: AGTCAGACAGGGTGCGCCC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  <p:sp>
        <p:nvSpPr>
          <p:cNvPr id="9" name="CasellaDiTesto 8"/>
          <p:cNvSpPr txBox="1"/>
          <p:nvPr/>
        </p:nvSpPr>
        <p:spPr>
          <a:xfrm>
            <a:off x="419595" y="404813"/>
            <a:ext cx="38446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  <a:cs typeface="Arial" panose="020B0604020202020204" pitchFamily="34" charset="0"/>
              </a:rPr>
              <a:t>Table S3</a:t>
            </a:r>
            <a:r>
              <a:rPr lang="en-GB" dirty="0">
                <a:latin typeface="Palatino Linotype" panose="02040502050505030304" pitchFamily="18" charset="0"/>
                <a:cs typeface="Arial" panose="020B0604020202020204" pitchFamily="34" charset="0"/>
              </a:rPr>
              <a:t>. Primer sequences</a:t>
            </a:r>
          </a:p>
        </p:txBody>
      </p:sp>
    </p:spTree>
    <p:extLst>
      <p:ext uri="{BB962C8B-B14F-4D97-AF65-F5344CB8AC3E}">
        <p14:creationId xmlns:p14="http://schemas.microsoft.com/office/powerpoint/2010/main" val="28797425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419594" y="404813"/>
            <a:ext cx="5316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  <a:cs typeface="Arial" panose="020B0604020202020204" pitchFamily="34" charset="0"/>
              </a:rPr>
              <a:t>Table S4</a:t>
            </a:r>
            <a:r>
              <a:rPr lang="en-GB" dirty="0">
                <a:latin typeface="Palatino Linotype" panose="02040502050505030304" pitchFamily="18" charset="0"/>
                <a:cs typeface="Arial" panose="020B0604020202020204" pitchFamily="34" charset="0"/>
              </a:rPr>
              <a:t>. Raw Ct of investigated transcripts</a:t>
            </a:r>
          </a:p>
        </p:txBody>
      </p:sp>
      <p:graphicFrame>
        <p:nvGraphicFramePr>
          <p:cNvPr id="8" name="Tabella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9491669"/>
              </p:ext>
            </p:extLst>
          </p:nvPr>
        </p:nvGraphicFramePr>
        <p:xfrm>
          <a:off x="3400122" y="1384686"/>
          <a:ext cx="4671318" cy="3469736"/>
        </p:xfrm>
        <a:graphic>
          <a:graphicData uri="http://schemas.openxmlformats.org/drawingml/2006/table">
            <a:tbl>
              <a:tblPr/>
              <a:tblGrid>
                <a:gridCol w="2732452">
                  <a:extLst>
                    <a:ext uri="{9D8B030D-6E8A-4147-A177-3AD203B41FA5}">
                      <a16:colId xmlns:a16="http://schemas.microsoft.com/office/drawing/2014/main" val="1807475920"/>
                    </a:ext>
                  </a:extLst>
                </a:gridCol>
                <a:gridCol w="1938866">
                  <a:extLst>
                    <a:ext uri="{9D8B030D-6E8A-4147-A177-3AD203B41FA5}">
                      <a16:colId xmlns:a16="http://schemas.microsoft.com/office/drawing/2014/main" val="1071754797"/>
                    </a:ext>
                  </a:extLst>
                </a:gridCol>
              </a:tblGrid>
              <a:tr h="340457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w</a:t>
                      </a:r>
                      <a:r>
                        <a:rPr lang="it-IT" sz="18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800" b="1" i="0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</a:t>
                      </a:r>
                      <a:endParaRPr lang="it-IT" sz="18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ng</a:t>
                      </a:r>
                      <a:r>
                        <a:rPr lang="it-IT" sz="18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VID</a:t>
                      </a:r>
                    </a:p>
                    <a:p>
                      <a:pPr algn="ctr" fontAlgn="b"/>
                      <a:r>
                        <a:rPr lang="it-IT" sz="1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it-IT" sz="18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SD</a:t>
                      </a:r>
                      <a:endParaRPr lang="it-IT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988590"/>
                  </a:ext>
                </a:extLst>
              </a:tr>
              <a:tr h="324982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G18-24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54 ± 2.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1636404"/>
                  </a:ext>
                </a:extLst>
              </a:tr>
              <a:tr h="348366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G18 long isoform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76 ± 1.0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906092"/>
                  </a:ext>
                </a:extLst>
              </a:tr>
              <a:tr h="324982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ncCEACAM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74 ± 0.88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4260840"/>
                  </a:ext>
                </a:extLst>
              </a:tr>
              <a:tr h="324982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1-AS1-20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46</a:t>
                      </a:r>
                      <a:r>
                        <a:rPr lang="it-IT" sz="1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4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0946969"/>
                  </a:ext>
                </a:extLst>
              </a:tr>
              <a:tr h="597838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1-AS1 multiple isoform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57 ± 1.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2153397"/>
                  </a:ext>
                </a:extLst>
              </a:tr>
              <a:tr h="324982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1-AS1-20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49</a:t>
                      </a:r>
                      <a:r>
                        <a:rPr lang="it-IT" sz="1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3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8241287"/>
                  </a:ext>
                </a:extLst>
              </a:tr>
              <a:tr h="324982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79</a:t>
                      </a:r>
                      <a:r>
                        <a:rPr lang="it-IT" sz="1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6261706"/>
                  </a:ext>
                </a:extLst>
              </a:tr>
              <a:tr h="340457">
                <a:tc>
                  <a:txBody>
                    <a:bodyPr/>
                    <a:lstStyle/>
                    <a:p>
                      <a:pPr algn="l" fontAlgn="b"/>
                      <a:r>
                        <a:rPr lang="it-IT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144-3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94</a:t>
                      </a:r>
                      <a:r>
                        <a:rPr lang="it-IT" sz="1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20433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618682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o 13"/>
          <p:cNvGrpSpPr/>
          <p:nvPr/>
        </p:nvGrpSpPr>
        <p:grpSpPr>
          <a:xfrm>
            <a:off x="2927833" y="-45967"/>
            <a:ext cx="6449667" cy="6267881"/>
            <a:chOff x="2886269" y="590119"/>
            <a:chExt cx="6449667" cy="6267881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59" t="17017" r="22157" b="11579"/>
            <a:stretch/>
          </p:blipFill>
          <p:spPr>
            <a:xfrm>
              <a:off x="3553691" y="1683327"/>
              <a:ext cx="4821382" cy="5174673"/>
            </a:xfrm>
            <a:prstGeom prst="rect">
              <a:avLst/>
            </a:prstGeom>
          </p:spPr>
        </p:pic>
        <p:sp>
          <p:nvSpPr>
            <p:cNvPr id="5" name="CasellaDiTesto 4"/>
            <p:cNvSpPr txBox="1"/>
            <p:nvPr/>
          </p:nvSpPr>
          <p:spPr>
            <a:xfrm>
              <a:off x="4364182" y="1181115"/>
              <a:ext cx="51608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GC</a:t>
              </a:r>
            </a:p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 1</a:t>
              </a:r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4901045" y="1181115"/>
              <a:ext cx="53339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GC</a:t>
              </a:r>
            </a:p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 2</a:t>
              </a: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5465618" y="1190285"/>
              <a:ext cx="51607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GC</a:t>
              </a:r>
            </a:p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 1</a:t>
              </a:r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6002480" y="1190285"/>
              <a:ext cx="56457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GC</a:t>
              </a:r>
            </a:p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 2</a:t>
              </a:r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6587836" y="1181115"/>
              <a:ext cx="54725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GC</a:t>
              </a:r>
            </a:p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 1</a:t>
              </a: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7135090" y="1181115"/>
              <a:ext cx="55418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GC</a:t>
              </a:r>
            </a:p>
            <a:p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 2</a:t>
              </a: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4364182" y="867417"/>
              <a:ext cx="9628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F1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5285508" y="711552"/>
              <a:ext cx="134389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F1-AS1</a:t>
              </a:r>
            </a:p>
            <a:p>
              <a:pPr algn="ctr"/>
              <a:r>
                <a:rPr lang="it-IT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7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6216446" y="590119"/>
              <a:ext cx="1707395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F1-AS1</a:t>
              </a:r>
            </a:p>
            <a:p>
              <a:pPr algn="ctr"/>
              <a:r>
                <a:rPr lang="it-IT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LTIPLE</a:t>
              </a:r>
            </a:p>
            <a:p>
              <a:pPr algn="ctr"/>
              <a:r>
                <a:rPr lang="it-IT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ISOFORMS</a:t>
              </a:r>
            </a:p>
          </p:txBody>
        </p:sp>
        <p:cxnSp>
          <p:nvCxnSpPr>
            <p:cNvPr id="15" name="Connettore 1 14"/>
            <p:cNvCxnSpPr/>
            <p:nvPr/>
          </p:nvCxnSpPr>
          <p:spPr>
            <a:xfrm>
              <a:off x="4499264" y="1154442"/>
              <a:ext cx="708313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ttore 1 16"/>
            <p:cNvCxnSpPr/>
            <p:nvPr/>
          </p:nvCxnSpPr>
          <p:spPr>
            <a:xfrm>
              <a:off x="5576453" y="1150977"/>
              <a:ext cx="708313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ttore 1 17"/>
            <p:cNvCxnSpPr/>
            <p:nvPr/>
          </p:nvCxnSpPr>
          <p:spPr>
            <a:xfrm>
              <a:off x="6715988" y="1168294"/>
              <a:ext cx="708313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1 18"/>
            <p:cNvCxnSpPr/>
            <p:nvPr/>
          </p:nvCxnSpPr>
          <p:spPr>
            <a:xfrm>
              <a:off x="8167252" y="5487444"/>
              <a:ext cx="288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ttore 1 19"/>
            <p:cNvCxnSpPr/>
            <p:nvPr/>
          </p:nvCxnSpPr>
          <p:spPr>
            <a:xfrm>
              <a:off x="8167252" y="5089125"/>
              <a:ext cx="288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 flipV="1">
              <a:off x="8164651" y="4852486"/>
              <a:ext cx="288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>
              <a:off x="3431308" y="5539399"/>
              <a:ext cx="288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1 22"/>
            <p:cNvCxnSpPr/>
            <p:nvPr/>
          </p:nvCxnSpPr>
          <p:spPr>
            <a:xfrm>
              <a:off x="3431304" y="5141080"/>
              <a:ext cx="288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ttore 1 23"/>
            <p:cNvCxnSpPr/>
            <p:nvPr/>
          </p:nvCxnSpPr>
          <p:spPr>
            <a:xfrm>
              <a:off x="3437168" y="4919407"/>
              <a:ext cx="288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asellaDiTesto 24"/>
            <p:cNvSpPr txBox="1"/>
            <p:nvPr/>
          </p:nvSpPr>
          <p:spPr>
            <a:xfrm>
              <a:off x="8390363" y="5364333"/>
              <a:ext cx="9455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/>
                <a:t>50 </a:t>
              </a:r>
              <a:r>
                <a:rPr lang="it-IT" sz="1100" b="1" dirty="0" err="1"/>
                <a:t>bp</a:t>
              </a:r>
              <a:endParaRPr lang="it-IT" sz="1100" b="1" dirty="0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8390360" y="4980508"/>
              <a:ext cx="9455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/>
                <a:t>100 </a:t>
              </a:r>
              <a:r>
                <a:rPr lang="it-IT" sz="1100" b="1" dirty="0" err="1"/>
                <a:t>bp</a:t>
              </a:r>
              <a:endParaRPr lang="it-IT" sz="1100" b="1" dirty="0"/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8390355" y="4739265"/>
              <a:ext cx="9455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/>
                <a:t>150 </a:t>
              </a:r>
              <a:r>
                <a:rPr lang="it-IT" sz="1100" b="1" dirty="0" err="1"/>
                <a:t>bp</a:t>
              </a:r>
              <a:endParaRPr lang="it-IT" sz="1100" b="1" dirty="0"/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2886270" y="5416288"/>
              <a:ext cx="9455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/>
                <a:t>   50 </a:t>
              </a:r>
              <a:r>
                <a:rPr lang="it-IT" sz="1100" b="1" dirty="0" err="1"/>
                <a:t>bp</a:t>
              </a:r>
              <a:endParaRPr lang="it-IT" sz="1100" b="1" dirty="0"/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2886270" y="5032463"/>
              <a:ext cx="9455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/>
                <a:t>100 </a:t>
              </a:r>
              <a:r>
                <a:rPr lang="it-IT" sz="1100" b="1" dirty="0" err="1"/>
                <a:t>bp</a:t>
              </a:r>
              <a:endParaRPr lang="it-IT" sz="1100" b="1" dirty="0"/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2886269" y="4791220"/>
              <a:ext cx="9455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/>
                <a:t>150 </a:t>
              </a:r>
              <a:r>
                <a:rPr lang="it-IT" sz="1100" b="1" dirty="0" err="1"/>
                <a:t>bp</a:t>
              </a:r>
              <a:endParaRPr lang="it-IT" sz="1100" b="1" dirty="0"/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3726870" y="1190284"/>
              <a:ext cx="51608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t-IT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7586663" y="1190283"/>
              <a:ext cx="51608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t-IT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33" name="CasellaDiTesto 32"/>
          <p:cNvSpPr txBox="1"/>
          <p:nvPr/>
        </p:nvSpPr>
        <p:spPr>
          <a:xfrm>
            <a:off x="103908" y="6205065"/>
            <a:ext cx="120880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8. </a:t>
            </a:r>
            <a:r>
              <a:rPr lang="en-GB" sz="1200" b="1" dirty="0">
                <a:latin typeface="Palatino Linotype" panose="02040502050505030304" pitchFamily="18" charset="0"/>
              </a:rPr>
              <a:t>Amplicons of LEF1 and LEF1-AS1 isoforms. </a:t>
            </a:r>
            <a:r>
              <a:rPr lang="en-GB" sz="1200" dirty="0">
                <a:latin typeface="Palatino Linotype" panose="02040502050505030304" pitchFamily="18" charset="0"/>
              </a:rPr>
              <a:t>Total RNA was extracted from the PBMC of 2 patients of the long COVID study. </a:t>
            </a:r>
            <a:r>
              <a:rPr lang="en-GB" sz="1200" dirty="0" err="1">
                <a:latin typeface="Palatino Linotype" panose="02040502050505030304" pitchFamily="18" charset="0"/>
              </a:rPr>
              <a:t>DNAse</a:t>
            </a:r>
            <a:r>
              <a:rPr lang="en-GB" sz="1200" dirty="0">
                <a:latin typeface="Palatino Linotype" panose="02040502050505030304" pitchFamily="18" charset="0"/>
              </a:rPr>
              <a:t> digestion and reverse transcription followed by PCR amplification for 40 cycles were performed in order to detect LEF1, LEF1-AS1-207, and LEF1-AS1 multiple isoforms. The agarose electrophoretic analysis shows a single detectable amplicon for each primer pair, indicating the specificity of the qPCR reactions.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6618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CasellaDiTesto 16"/>
          <p:cNvSpPr txBox="1"/>
          <p:nvPr/>
        </p:nvSpPr>
        <p:spPr>
          <a:xfrm>
            <a:off x="103908" y="6069043"/>
            <a:ext cx="120880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2. </a:t>
            </a:r>
            <a:r>
              <a:rPr lang="en-GB" sz="1200" b="1" dirty="0">
                <a:latin typeface="Palatino Linotype" panose="02040502050505030304" pitchFamily="18" charset="0"/>
              </a:rPr>
              <a:t>No significant differences in </a:t>
            </a:r>
            <a:r>
              <a:rPr lang="en-GB" sz="1200" b="1" dirty="0" err="1">
                <a:latin typeface="Palatino Linotype" panose="02040502050505030304" pitchFamily="18" charset="0"/>
              </a:rPr>
              <a:t>lncRNA</a:t>
            </a:r>
            <a:r>
              <a:rPr lang="en-GB" sz="1200" b="1" dirty="0">
                <a:latin typeface="Palatino Linotype" panose="02040502050505030304" pitchFamily="18" charset="0"/>
              </a:rPr>
              <a:t> expression levels between patients with and without major neuropsychological symptoms (MNS) . </a:t>
            </a:r>
            <a:r>
              <a:rPr lang="en-GB" sz="1200" dirty="0">
                <a:latin typeface="Palatino Linotype" panose="02040502050505030304" pitchFamily="18" charset="0"/>
              </a:rPr>
              <a:t>LEF1-AS1-202 (A), HCG18-244 (B), HCG18 long isoforms (C) and lncCEACAM21 (D) were measured in total RNAs extracted from the PBMC of no MNS (n = 59) and MNS patients (n = 35-39). Values are represented as log</a:t>
            </a:r>
            <a:r>
              <a:rPr lang="en-GB" sz="1200" baseline="-25000" dirty="0">
                <a:latin typeface="Palatino Linotype" panose="02040502050505030304" pitchFamily="18" charset="0"/>
              </a:rPr>
              <a:t>2</a:t>
            </a:r>
            <a:r>
              <a:rPr lang="en-GB" sz="1200" dirty="0">
                <a:latin typeface="Palatino Linotype" panose="02040502050505030304" pitchFamily="18" charset="0"/>
              </a:rPr>
              <a:t> fold changes and shown using violin plots, with dashed lines indicating the median and dotted lines denoting the second and third quartiles. Unpaired t-test (two groups) was used for statistical comparison: differences were not statistically significant. 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7" name="Immagine 6" descr="Immagine che contiene testo, diagramma, Carattere, linea&#10;&#10;Descrizione generata automaticamente">
            <a:extLst>
              <a:ext uri="{FF2B5EF4-FFF2-40B4-BE49-F238E27FC236}">
                <a16:creationId xmlns:a16="http://schemas.microsoft.com/office/drawing/2014/main" id="{FFD4F9A8-12E9-8940-819F-DF193F6CA47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9387" y="75046"/>
            <a:ext cx="7610180" cy="5987106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6006944" y="-66747"/>
            <a:ext cx="455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2119387" y="2933697"/>
            <a:ext cx="455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CasellaDiTesto 10"/>
          <p:cNvSpPr txBox="1"/>
          <p:nvPr/>
        </p:nvSpPr>
        <p:spPr>
          <a:xfrm>
            <a:off x="6006944" y="2933697"/>
            <a:ext cx="455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2104228" y="-51358"/>
            <a:ext cx="455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9246318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/>
          <p:cNvGrpSpPr/>
          <p:nvPr/>
        </p:nvGrpSpPr>
        <p:grpSpPr>
          <a:xfrm>
            <a:off x="240892" y="423712"/>
            <a:ext cx="8901160" cy="5072421"/>
            <a:chOff x="240892" y="423712"/>
            <a:chExt cx="8901160" cy="5072421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 rotWithShape="1">
            <a:blip r:embed="rId2"/>
            <a:srcRect l="14306" t="23457" r="11426" b="11358"/>
            <a:stretch/>
          </p:blipFill>
          <p:spPr>
            <a:xfrm>
              <a:off x="240892" y="445293"/>
              <a:ext cx="8901160" cy="5050840"/>
            </a:xfrm>
            <a:prstGeom prst="rect">
              <a:avLst/>
            </a:prstGeom>
          </p:spPr>
        </p:pic>
        <p:sp>
          <p:nvSpPr>
            <p:cNvPr id="5" name="Rettangolo 4"/>
            <p:cNvSpPr/>
            <p:nvPr/>
          </p:nvSpPr>
          <p:spPr>
            <a:xfrm>
              <a:off x="240892" y="423712"/>
              <a:ext cx="8134829" cy="31861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GB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ttangolo 5"/>
            <p:cNvSpPr/>
            <p:nvPr/>
          </p:nvSpPr>
          <p:spPr>
            <a:xfrm>
              <a:off x="2262927" y="2680921"/>
              <a:ext cx="1567186" cy="34353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Rettangolo 6"/>
            <p:cNvSpPr/>
            <p:nvPr/>
          </p:nvSpPr>
          <p:spPr>
            <a:xfrm>
              <a:off x="2273813" y="3688302"/>
              <a:ext cx="1567186" cy="380670"/>
            </a:xfrm>
            <a:prstGeom prst="rect">
              <a:avLst/>
            </a:prstGeom>
            <a:noFill/>
            <a:ln w="285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Rettangolo 7"/>
            <p:cNvSpPr/>
            <p:nvPr/>
          </p:nvSpPr>
          <p:spPr>
            <a:xfrm>
              <a:off x="2262926" y="940048"/>
              <a:ext cx="6874616" cy="1713017"/>
            </a:xfrm>
            <a:prstGeom prst="rect">
              <a:avLst/>
            </a:prstGeom>
            <a:noFill/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805544" y="1433225"/>
              <a:ext cx="15419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EF1-AS1</a:t>
              </a:r>
            </a:p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ultiple </a:t>
              </a:r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soforms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808087" y="2680921"/>
              <a:ext cx="1502560" cy="286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EF1-AS1-207</a:t>
              </a: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829862" y="3688302"/>
              <a:ext cx="1502560" cy="286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EF1-AS1-202</a:t>
              </a:r>
            </a:p>
          </p:txBody>
        </p:sp>
      </p:grpSp>
      <p:sp>
        <p:nvSpPr>
          <p:cNvPr id="16" name="CasellaDiTesto 15"/>
          <p:cNvSpPr txBox="1"/>
          <p:nvPr/>
        </p:nvSpPr>
        <p:spPr>
          <a:xfrm>
            <a:off x="0" y="5821262"/>
            <a:ext cx="120880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3. </a:t>
            </a:r>
            <a:r>
              <a:rPr lang="en-GB" sz="1200" b="1" dirty="0">
                <a:latin typeface="Palatino Linotype" panose="02040502050505030304" pitchFamily="18" charset="0"/>
              </a:rPr>
              <a:t>LEF1-AS1 locus transcript annotation and qPCR primer pairs. </a:t>
            </a:r>
            <a:r>
              <a:rPr lang="en-GB" sz="1200" dirty="0">
                <a:latin typeface="Palatino Linotype" panose="02040502050505030304" pitchFamily="18" charset="0"/>
              </a:rPr>
              <a:t>In panel A, the green box represents all isoforms identified as multiple isoforms, while the red and blue boxes represent LEF1-AS1-207 and LEF1-AS1-202 isoforms, respectively. Panel B zooms in on 5’ region, where the green, red and blue brackets indicate the position of the primers used to detect LEF1-AS1 multiple isoforms, LEF1-AS1-207 and LEF1-AS1-202, respectively. The representation of the locus was obtained by </a:t>
            </a:r>
            <a:r>
              <a:rPr lang="en-GB" sz="1200" dirty="0" err="1">
                <a:latin typeface="Palatino Linotype" panose="02040502050505030304" pitchFamily="18" charset="0"/>
              </a:rPr>
              <a:t>Ensembl</a:t>
            </a:r>
            <a:r>
              <a:rPr lang="en-GB" sz="1200" dirty="0">
                <a:latin typeface="Palatino Linotype" panose="02040502050505030304" pitchFamily="18" charset="0"/>
              </a:rPr>
              <a:t> genome browser (Chromosome 4: 108,167,525-108,258,037 forward strand; GRCh38:CM000666.2).</a:t>
            </a:r>
            <a:r>
              <a:rPr lang="en-GB" sz="1200" b="1" dirty="0">
                <a:latin typeface="Palatino Linotype" panose="02040502050505030304" pitchFamily="18" charset="0"/>
              </a:rPr>
              <a:t> </a:t>
            </a:r>
            <a:endParaRPr lang="en-GB" sz="1200" dirty="0">
              <a:latin typeface="Palatino Linotype" panose="02040502050505030304" pitchFamily="18" charset="0"/>
            </a:endParaRPr>
          </a:p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0" y="-89157"/>
            <a:ext cx="4406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CasellaDiTesto 18"/>
          <p:cNvSpPr txBox="1"/>
          <p:nvPr/>
        </p:nvSpPr>
        <p:spPr>
          <a:xfrm>
            <a:off x="9174728" y="-89157"/>
            <a:ext cx="4406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2" name="Gruppo 31"/>
          <p:cNvGrpSpPr/>
          <p:nvPr/>
        </p:nvGrpSpPr>
        <p:grpSpPr>
          <a:xfrm>
            <a:off x="9615419" y="141675"/>
            <a:ext cx="1981199" cy="5636496"/>
            <a:chOff x="10246581" y="593698"/>
            <a:chExt cx="1557781" cy="5231992"/>
          </a:xfrm>
        </p:grpSpPr>
        <p:pic>
          <p:nvPicPr>
            <p:cNvPr id="17" name="Immagine 16"/>
            <p:cNvPicPr>
              <a:picLocks noChangeAspect="1"/>
            </p:cNvPicPr>
            <p:nvPr/>
          </p:nvPicPr>
          <p:blipFill rotWithShape="1">
            <a:blip r:embed="rId2"/>
            <a:srcRect l="27893" t="23457" r="63008" b="11358"/>
            <a:stretch/>
          </p:blipFill>
          <p:spPr>
            <a:xfrm>
              <a:off x="10246581" y="593698"/>
              <a:ext cx="1557781" cy="5231992"/>
            </a:xfrm>
            <a:prstGeom prst="rect">
              <a:avLst/>
            </a:prstGeom>
          </p:spPr>
        </p:pic>
        <p:cxnSp>
          <p:nvCxnSpPr>
            <p:cNvPr id="9" name="Connettore 1 8"/>
            <p:cNvCxnSpPr/>
            <p:nvPr/>
          </p:nvCxnSpPr>
          <p:spPr>
            <a:xfrm>
              <a:off x="10872502" y="1077687"/>
              <a:ext cx="198143" cy="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10874829" y="1066801"/>
              <a:ext cx="0" cy="7200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1 22"/>
            <p:cNvCxnSpPr/>
            <p:nvPr/>
          </p:nvCxnSpPr>
          <p:spPr>
            <a:xfrm>
              <a:off x="11062213" y="1066797"/>
              <a:ext cx="0" cy="7200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ttore 1 23"/>
            <p:cNvCxnSpPr/>
            <p:nvPr/>
          </p:nvCxnSpPr>
          <p:spPr>
            <a:xfrm>
              <a:off x="10926934" y="2906488"/>
              <a:ext cx="0" cy="720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1 24"/>
            <p:cNvCxnSpPr/>
            <p:nvPr/>
          </p:nvCxnSpPr>
          <p:spPr>
            <a:xfrm>
              <a:off x="11005459" y="2906484"/>
              <a:ext cx="0" cy="720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ttore 1 26"/>
            <p:cNvCxnSpPr/>
            <p:nvPr/>
          </p:nvCxnSpPr>
          <p:spPr>
            <a:xfrm>
              <a:off x="10918375" y="2917370"/>
              <a:ext cx="8708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ttore 1 27"/>
            <p:cNvCxnSpPr/>
            <p:nvPr/>
          </p:nvCxnSpPr>
          <p:spPr>
            <a:xfrm>
              <a:off x="11125203" y="3984169"/>
              <a:ext cx="0" cy="72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1 28"/>
            <p:cNvCxnSpPr/>
            <p:nvPr/>
          </p:nvCxnSpPr>
          <p:spPr>
            <a:xfrm>
              <a:off x="11321147" y="3984165"/>
              <a:ext cx="0" cy="72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1 30"/>
            <p:cNvCxnSpPr/>
            <p:nvPr/>
          </p:nvCxnSpPr>
          <p:spPr>
            <a:xfrm flipV="1">
              <a:off x="11125203" y="3995051"/>
              <a:ext cx="195944" cy="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998974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asellaDiTesto 11"/>
          <p:cNvSpPr txBox="1"/>
          <p:nvPr/>
        </p:nvSpPr>
        <p:spPr>
          <a:xfrm>
            <a:off x="0" y="5425410"/>
            <a:ext cx="120880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4. </a:t>
            </a:r>
            <a:r>
              <a:rPr lang="en-GB" sz="1200" b="1" dirty="0">
                <a:latin typeface="Palatino Linotype" panose="02040502050505030304" pitchFamily="18" charset="0"/>
              </a:rPr>
              <a:t>No significant differences in LEF1-AS1 isoforms and LEF1 expression levels between patients with and without major neuropsychological symptoms (MNS). </a:t>
            </a:r>
            <a:r>
              <a:rPr lang="en-GB" sz="1200" dirty="0">
                <a:latin typeface="Palatino Linotype" panose="02040502050505030304" pitchFamily="18" charset="0"/>
              </a:rPr>
              <a:t>LEF1-AS1 multiple isoforms (A), LEF1-AS1-207 (B), and LEF1 (C) were measured in total RNAs extracted from the PBMCs of patients with MNS (MNS, n = 39) or without MNS (no MNS, n = 59). Unpaired t-test (two groups) was used for statistical comparison: differences were not statistically significant.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pSp>
        <p:nvGrpSpPr>
          <p:cNvPr id="5" name="Gruppo 4">
            <a:extLst>
              <a:ext uri="{FF2B5EF4-FFF2-40B4-BE49-F238E27FC236}">
                <a16:creationId xmlns:a16="http://schemas.microsoft.com/office/drawing/2014/main" id="{43C8DA98-9C76-A843-BD2C-6808DFE35123}"/>
              </a:ext>
            </a:extLst>
          </p:cNvPr>
          <p:cNvGrpSpPr/>
          <p:nvPr/>
        </p:nvGrpSpPr>
        <p:grpSpPr>
          <a:xfrm>
            <a:off x="0" y="952246"/>
            <a:ext cx="11862386" cy="3466988"/>
            <a:chOff x="0" y="952246"/>
            <a:chExt cx="11862386" cy="3466988"/>
          </a:xfrm>
        </p:grpSpPr>
        <p:pic>
          <p:nvPicPr>
            <p:cNvPr id="4" name="Immagine 3" descr="Immagine che contiene testo, linea, Carattere, diagramma&#10;&#10;Descrizione generata automaticamente">
              <a:extLst>
                <a:ext uri="{FF2B5EF4-FFF2-40B4-BE49-F238E27FC236}">
                  <a16:creationId xmlns:a16="http://schemas.microsoft.com/office/drawing/2014/main" id="{402373DF-E1F8-5643-BA9F-13876494FB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952246"/>
              <a:ext cx="11862386" cy="3466988"/>
            </a:xfrm>
            <a:prstGeom prst="rect">
              <a:avLst/>
            </a:prstGeom>
          </p:spPr>
        </p:pic>
        <p:sp>
          <p:nvSpPr>
            <p:cNvPr id="20" name="CasellaDiTesto 19"/>
            <p:cNvSpPr txBox="1"/>
            <p:nvPr/>
          </p:nvSpPr>
          <p:spPr>
            <a:xfrm>
              <a:off x="225706" y="1075520"/>
              <a:ext cx="446543" cy="4087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4142923" y="1106966"/>
              <a:ext cx="446543" cy="4087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8017400" y="1091243"/>
              <a:ext cx="446543" cy="4087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222149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Rettangolo 35"/>
          <p:cNvSpPr/>
          <p:nvPr/>
        </p:nvSpPr>
        <p:spPr>
          <a:xfrm>
            <a:off x="213924" y="6162297"/>
            <a:ext cx="1176827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5. 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nivariate logistic regression analysis showing LEF1-AS1 and LEF1 association with post-COVID-19 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jor physical symptoms (MPS) 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ccurrence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The forest plot displays the odds ratio (OR) with a ± 95 % confidence interval (95% CI) and the corresponding p-values for each variable. A p-value ≤ 0.05 is considered significant.</a:t>
            </a:r>
            <a:endParaRPr lang="en-GB" sz="1200" dirty="0">
              <a:latin typeface="Palatino Linotype" panose="02040502050505030304" pitchFamily="18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1634271" y="339462"/>
            <a:ext cx="8793779" cy="5554653"/>
            <a:chOff x="1634271" y="339462"/>
            <a:chExt cx="8793779" cy="5554653"/>
          </a:xfrm>
        </p:grpSpPr>
        <p:grpSp>
          <p:nvGrpSpPr>
            <p:cNvPr id="4" name="Gruppo 3"/>
            <p:cNvGrpSpPr/>
            <p:nvPr/>
          </p:nvGrpSpPr>
          <p:grpSpPr>
            <a:xfrm>
              <a:off x="1634271" y="339462"/>
              <a:ext cx="5196789" cy="5554653"/>
              <a:chOff x="2466753" y="676260"/>
              <a:chExt cx="5196789" cy="5554653"/>
            </a:xfrm>
          </p:grpSpPr>
          <p:grpSp>
            <p:nvGrpSpPr>
              <p:cNvPr id="5" name="Gruppo 4"/>
              <p:cNvGrpSpPr/>
              <p:nvPr/>
            </p:nvGrpSpPr>
            <p:grpSpPr>
              <a:xfrm>
                <a:off x="4151671" y="676260"/>
                <a:ext cx="3511871" cy="5505480"/>
                <a:chOff x="4151671" y="676260"/>
                <a:chExt cx="3511871" cy="5505480"/>
              </a:xfrm>
            </p:grpSpPr>
            <p:grpSp>
              <p:nvGrpSpPr>
                <p:cNvPr id="15" name="Gruppo 14"/>
                <p:cNvGrpSpPr/>
                <p:nvPr/>
              </p:nvGrpSpPr>
              <p:grpSpPr>
                <a:xfrm>
                  <a:off x="4151671" y="676260"/>
                  <a:ext cx="3511871" cy="5505480"/>
                  <a:chOff x="4151671" y="676260"/>
                  <a:chExt cx="3511871" cy="5505480"/>
                </a:xfrm>
              </p:grpSpPr>
              <p:pic>
                <p:nvPicPr>
                  <p:cNvPr id="32" name="Immagine 31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27755" r="70660"/>
                  <a:stretch/>
                </p:blipFill>
                <p:spPr>
                  <a:xfrm>
                    <a:off x="4223649" y="676260"/>
                    <a:ext cx="108858" cy="5505480"/>
                  </a:xfrm>
                  <a:prstGeom prst="rect">
                    <a:avLst/>
                  </a:prstGeom>
                </p:spPr>
              </p:pic>
              <p:pic>
                <p:nvPicPr>
                  <p:cNvPr id="33" name="Immagine 32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51837" r="-634"/>
                  <a:stretch/>
                </p:blipFill>
                <p:spPr>
                  <a:xfrm>
                    <a:off x="4310743" y="676260"/>
                    <a:ext cx="3352799" cy="5505480"/>
                  </a:xfrm>
                  <a:prstGeom prst="rect">
                    <a:avLst/>
                  </a:prstGeom>
                </p:spPr>
              </p:pic>
              <p:sp>
                <p:nvSpPr>
                  <p:cNvPr id="34" name="Rettangolo 33"/>
                  <p:cNvSpPr/>
                  <p:nvPr/>
                </p:nvSpPr>
                <p:spPr>
                  <a:xfrm>
                    <a:off x="4151671" y="5965723"/>
                    <a:ext cx="180836" cy="21601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sp>
              <p:nvSpPr>
                <p:cNvPr id="16" name="Ovale 15"/>
                <p:cNvSpPr/>
                <p:nvPr/>
              </p:nvSpPr>
              <p:spPr>
                <a:xfrm>
                  <a:off x="5816009" y="1552353"/>
                  <a:ext cx="74430" cy="63795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7" name="Ovale 16"/>
                <p:cNvSpPr/>
                <p:nvPr/>
              </p:nvSpPr>
              <p:spPr>
                <a:xfrm>
                  <a:off x="5819552" y="2704219"/>
                  <a:ext cx="74430" cy="63795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8" name="Ovale 17"/>
                <p:cNvSpPr/>
                <p:nvPr/>
              </p:nvSpPr>
              <p:spPr>
                <a:xfrm>
                  <a:off x="5734483" y="3863172"/>
                  <a:ext cx="74430" cy="63795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9" name="Ovale 18"/>
                <p:cNvSpPr/>
                <p:nvPr/>
              </p:nvSpPr>
              <p:spPr>
                <a:xfrm>
                  <a:off x="5543097" y="5011487"/>
                  <a:ext cx="74430" cy="63795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20" name="Connettore 1 19"/>
                <p:cNvCxnSpPr/>
                <p:nvPr/>
              </p:nvCxnSpPr>
              <p:spPr>
                <a:xfrm>
                  <a:off x="5156791" y="1584250"/>
                  <a:ext cx="1605516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Connettore 1 20"/>
                <p:cNvCxnSpPr/>
                <p:nvPr/>
              </p:nvCxnSpPr>
              <p:spPr>
                <a:xfrm>
                  <a:off x="4995522" y="2736116"/>
                  <a:ext cx="2043231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Connettore 1 21"/>
                <p:cNvCxnSpPr/>
                <p:nvPr/>
              </p:nvCxnSpPr>
              <p:spPr>
                <a:xfrm>
                  <a:off x="4958307" y="3895069"/>
                  <a:ext cx="1942223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Connettore 1 22"/>
                <p:cNvCxnSpPr/>
                <p:nvPr/>
              </p:nvCxnSpPr>
              <p:spPr>
                <a:xfrm flipV="1">
                  <a:off x="4685406" y="5043384"/>
                  <a:ext cx="2160000" cy="3543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Connettore 1 23"/>
                <p:cNvCxnSpPr/>
                <p:nvPr/>
              </p:nvCxnSpPr>
              <p:spPr>
                <a:xfrm>
                  <a:off x="5156791" y="1435395"/>
                  <a:ext cx="0" cy="28707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Connettore 1 24"/>
                <p:cNvCxnSpPr/>
                <p:nvPr/>
              </p:nvCxnSpPr>
              <p:spPr>
                <a:xfrm>
                  <a:off x="6762307" y="1444254"/>
                  <a:ext cx="0" cy="28707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Connettore 1 25"/>
                <p:cNvCxnSpPr/>
                <p:nvPr/>
              </p:nvCxnSpPr>
              <p:spPr>
                <a:xfrm>
                  <a:off x="4996745" y="2597280"/>
                  <a:ext cx="0" cy="28707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Connettore 1 26"/>
                <p:cNvCxnSpPr/>
                <p:nvPr/>
              </p:nvCxnSpPr>
              <p:spPr>
                <a:xfrm>
                  <a:off x="7038753" y="2590805"/>
                  <a:ext cx="0" cy="28707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Connettore 1 27"/>
                <p:cNvCxnSpPr/>
                <p:nvPr/>
              </p:nvCxnSpPr>
              <p:spPr>
                <a:xfrm>
                  <a:off x="4954151" y="3747373"/>
                  <a:ext cx="0" cy="28707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Connettore 1 28"/>
                <p:cNvCxnSpPr/>
                <p:nvPr/>
              </p:nvCxnSpPr>
              <p:spPr>
                <a:xfrm>
                  <a:off x="6897250" y="3746297"/>
                  <a:ext cx="0" cy="28707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Connettore 1 29"/>
                <p:cNvCxnSpPr/>
                <p:nvPr/>
              </p:nvCxnSpPr>
              <p:spPr>
                <a:xfrm>
                  <a:off x="4697874" y="4899844"/>
                  <a:ext cx="0" cy="28707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Connettore 1 30"/>
                <p:cNvCxnSpPr/>
                <p:nvPr/>
              </p:nvCxnSpPr>
              <p:spPr>
                <a:xfrm>
                  <a:off x="6845406" y="4899843"/>
                  <a:ext cx="0" cy="28707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" name="CasellaDiTesto 5"/>
              <p:cNvSpPr txBox="1"/>
              <p:nvPr/>
            </p:nvSpPr>
            <p:spPr>
              <a:xfrm>
                <a:off x="3395049" y="4858716"/>
                <a:ext cx="81812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F1</a:t>
                </a:r>
                <a:endParaRPr lang="en-GB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CasellaDiTesto 6"/>
              <p:cNvSpPr txBox="1"/>
              <p:nvPr/>
            </p:nvSpPr>
            <p:spPr>
              <a:xfrm>
                <a:off x="2466753" y="3705170"/>
                <a:ext cx="17473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F1-AS1-202</a:t>
                </a:r>
                <a:endParaRPr lang="en-GB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CasellaDiTesto 7"/>
              <p:cNvSpPr txBox="1"/>
              <p:nvPr/>
            </p:nvSpPr>
            <p:spPr>
              <a:xfrm>
                <a:off x="2466753" y="2549678"/>
                <a:ext cx="1746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F1-AS1-207</a:t>
                </a:r>
                <a:endParaRPr lang="en-GB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CasellaDiTesto 8"/>
              <p:cNvSpPr txBox="1"/>
              <p:nvPr/>
            </p:nvSpPr>
            <p:spPr>
              <a:xfrm>
                <a:off x="2586499" y="1126128"/>
                <a:ext cx="1646019" cy="9233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F1-AS1 multiple </a:t>
                </a:r>
                <a:r>
                  <a:rPr lang="it-IT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soforms</a:t>
                </a:r>
                <a:endParaRPr lang="en-GB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ttangolo 9"/>
              <p:cNvSpPr/>
              <p:nvPr/>
            </p:nvSpPr>
            <p:spPr>
              <a:xfrm>
                <a:off x="4332507" y="5965723"/>
                <a:ext cx="2993326" cy="21601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" name="CasellaDiTesto 10"/>
              <p:cNvSpPr txBox="1"/>
              <p:nvPr/>
            </p:nvSpPr>
            <p:spPr>
              <a:xfrm>
                <a:off x="4175839" y="5963624"/>
                <a:ext cx="5377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lang="en-GB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CasellaDiTesto 11"/>
              <p:cNvSpPr txBox="1"/>
              <p:nvPr/>
            </p:nvSpPr>
            <p:spPr>
              <a:xfrm>
                <a:off x="5045276" y="5968422"/>
                <a:ext cx="5377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lang="en-GB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CasellaDiTesto 12"/>
              <p:cNvSpPr txBox="1"/>
              <p:nvPr/>
            </p:nvSpPr>
            <p:spPr>
              <a:xfrm>
                <a:off x="5916702" y="5969303"/>
                <a:ext cx="5377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en-GB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>
                <a:off x="6788129" y="5965693"/>
                <a:ext cx="5377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GB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" name="CasellaDiTesto 36"/>
            <p:cNvSpPr txBox="1"/>
            <p:nvPr/>
          </p:nvSpPr>
          <p:spPr>
            <a:xfrm>
              <a:off x="7065820" y="581891"/>
              <a:ext cx="10859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OR</a:t>
              </a:r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7989348" y="581891"/>
              <a:ext cx="10859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95% CI</a:t>
              </a: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9221642" y="581891"/>
              <a:ext cx="10859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it-IT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it-IT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6896903" y="3327246"/>
              <a:ext cx="9381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71</a:t>
              </a:r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7908967" y="3327246"/>
              <a:ext cx="123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52-0.96</a:t>
              </a:r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9195998" y="3327246"/>
              <a:ext cx="123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</a:p>
          </p:txBody>
        </p:sp>
        <p:sp>
          <p:nvSpPr>
            <p:cNvPr id="43" name="CasellaDiTesto 42"/>
            <p:cNvSpPr txBox="1"/>
            <p:nvPr/>
          </p:nvSpPr>
          <p:spPr>
            <a:xfrm>
              <a:off x="6896903" y="1019569"/>
              <a:ext cx="9381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73</a:t>
              </a:r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7908967" y="1019569"/>
              <a:ext cx="123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56-0.93</a:t>
              </a:r>
            </a:p>
          </p:txBody>
        </p:sp>
        <p:sp>
          <p:nvSpPr>
            <p:cNvPr id="45" name="CasellaDiTesto 44"/>
            <p:cNvSpPr txBox="1"/>
            <p:nvPr/>
          </p:nvSpPr>
          <p:spPr>
            <a:xfrm>
              <a:off x="9195998" y="1019569"/>
              <a:ext cx="123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</p:txBody>
        </p:sp>
        <p:sp>
          <p:nvSpPr>
            <p:cNvPr id="46" name="CasellaDiTesto 45"/>
            <p:cNvSpPr txBox="1"/>
            <p:nvPr/>
          </p:nvSpPr>
          <p:spPr>
            <a:xfrm>
              <a:off x="6896903" y="2212880"/>
              <a:ext cx="9381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73</a:t>
              </a:r>
            </a:p>
          </p:txBody>
        </p:sp>
        <p:sp>
          <p:nvSpPr>
            <p:cNvPr id="47" name="CasellaDiTesto 46"/>
            <p:cNvSpPr txBox="1"/>
            <p:nvPr/>
          </p:nvSpPr>
          <p:spPr>
            <a:xfrm>
              <a:off x="7908967" y="2212880"/>
              <a:ext cx="123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53-1.00</a:t>
              </a:r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9195998" y="2212880"/>
              <a:ext cx="123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6898562" y="4563045"/>
              <a:ext cx="9381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66</a:t>
              </a:r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7910626" y="4563045"/>
              <a:ext cx="123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46-0.95</a:t>
              </a: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9197657" y="4563045"/>
              <a:ext cx="123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765708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/>
          <p:cNvSpPr/>
          <p:nvPr/>
        </p:nvSpPr>
        <p:spPr>
          <a:xfrm>
            <a:off x="223788" y="6194564"/>
            <a:ext cx="1176827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6. </a:t>
            </a:r>
            <a:r>
              <a:rPr lang="it-IT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Correlations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of LEF1-AS1 </a:t>
            </a:r>
            <a:r>
              <a:rPr lang="it-IT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isoforms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and LEF1 with </a:t>
            </a:r>
            <a:r>
              <a:rPr lang="it-IT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clinically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relevant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parameters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orrelation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for LEF1-AS1-202 (A, B,C), LEF1-AS1 multiple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isoform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(D,E), LEF1-AS1-207 (F,G) and LEF1 (H)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re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alculated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using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pearman’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orrelation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test.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oefficient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nd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value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re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indicated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Red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nd green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quare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indicate major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hysical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ymptom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(MPS)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atient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n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= 48) and no MPS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atients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n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= 49),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respectively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.  </a:t>
            </a:r>
            <a:endParaRPr lang="en-GB" sz="1200" dirty="0">
              <a:latin typeface="Palatino Linotype" panose="02040502050505030304" pitchFamily="18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3438272" y="-72973"/>
            <a:ext cx="5397256" cy="6198351"/>
            <a:chOff x="3438272" y="-72973"/>
            <a:chExt cx="5383375" cy="6396335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38272" y="0"/>
              <a:ext cx="5383375" cy="6323362"/>
            </a:xfrm>
            <a:prstGeom prst="rect">
              <a:avLst/>
            </a:prstGeom>
          </p:spPr>
        </p:pic>
        <p:sp>
          <p:nvSpPr>
            <p:cNvPr id="4" name="CasellaDiTesto 3"/>
            <p:cNvSpPr txBox="1"/>
            <p:nvPr/>
          </p:nvSpPr>
          <p:spPr>
            <a:xfrm>
              <a:off x="3438272" y="-72973"/>
              <a:ext cx="275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5165075" y="-71396"/>
              <a:ext cx="275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6855650" y="-72973"/>
              <a:ext cx="275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3438272" y="1544670"/>
              <a:ext cx="275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5221169" y="1544669"/>
              <a:ext cx="275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3438272" y="3173329"/>
              <a:ext cx="275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5165075" y="3173328"/>
              <a:ext cx="275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3438272" y="4747690"/>
              <a:ext cx="275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824623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056757" y="1996738"/>
            <a:ext cx="10220145" cy="2658992"/>
            <a:chOff x="709623" y="2657138"/>
            <a:chExt cx="10220145" cy="2658992"/>
          </a:xfrm>
        </p:grpSpPr>
        <p:sp>
          <p:nvSpPr>
            <p:cNvPr id="5" name="Pentagono 4"/>
            <p:cNvSpPr/>
            <p:nvPr/>
          </p:nvSpPr>
          <p:spPr>
            <a:xfrm>
              <a:off x="731520" y="2657139"/>
              <a:ext cx="2882524" cy="923330"/>
            </a:xfrm>
            <a:prstGeom prst="homePlate">
              <a:avLst/>
            </a:prstGeom>
            <a:gradFill flip="none" rotWithShape="1">
              <a:gsLst>
                <a:gs pos="0">
                  <a:schemeClr val="accent1">
                    <a:tint val="66000"/>
                    <a:satMod val="160000"/>
                  </a:schemeClr>
                </a:gs>
                <a:gs pos="50000">
                  <a:schemeClr val="accent1">
                    <a:tint val="44500"/>
                    <a:satMod val="160000"/>
                  </a:schemeClr>
                </a:gs>
                <a:gs pos="100000">
                  <a:schemeClr val="accent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Gallone 5"/>
            <p:cNvSpPr/>
            <p:nvPr/>
          </p:nvSpPr>
          <p:spPr>
            <a:xfrm>
              <a:off x="3410175" y="2657139"/>
              <a:ext cx="2614111" cy="923330"/>
            </a:xfrm>
            <a:prstGeom prst="chevron">
              <a:avLst/>
            </a:prstGeom>
            <a:gradFill flip="none" rotWithShape="1">
              <a:gsLst>
                <a:gs pos="0">
                  <a:schemeClr val="accent1">
                    <a:tint val="66000"/>
                    <a:satMod val="160000"/>
                  </a:schemeClr>
                </a:gs>
                <a:gs pos="50000">
                  <a:schemeClr val="accent1">
                    <a:tint val="44500"/>
                    <a:satMod val="160000"/>
                  </a:schemeClr>
                </a:gs>
                <a:gs pos="100000">
                  <a:schemeClr val="accent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Gallone 6"/>
            <p:cNvSpPr/>
            <p:nvPr/>
          </p:nvSpPr>
          <p:spPr>
            <a:xfrm>
              <a:off x="5853953" y="2657139"/>
              <a:ext cx="2614111" cy="923330"/>
            </a:xfrm>
            <a:prstGeom prst="chevron">
              <a:avLst/>
            </a:prstGeom>
            <a:gradFill flip="none" rotWithShape="1">
              <a:gsLst>
                <a:gs pos="0">
                  <a:schemeClr val="accent1">
                    <a:tint val="66000"/>
                    <a:satMod val="160000"/>
                  </a:schemeClr>
                </a:gs>
                <a:gs pos="50000">
                  <a:schemeClr val="accent1">
                    <a:tint val="44500"/>
                    <a:satMod val="160000"/>
                  </a:schemeClr>
                </a:gs>
                <a:gs pos="100000">
                  <a:schemeClr val="accent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Gallone 7"/>
            <p:cNvSpPr/>
            <p:nvPr/>
          </p:nvSpPr>
          <p:spPr>
            <a:xfrm>
              <a:off x="8315657" y="2657138"/>
              <a:ext cx="2614111" cy="923330"/>
            </a:xfrm>
            <a:prstGeom prst="chevron">
              <a:avLst/>
            </a:prstGeom>
            <a:gradFill flip="none" rotWithShape="1">
              <a:gsLst>
                <a:gs pos="0">
                  <a:schemeClr val="accent1">
                    <a:tint val="66000"/>
                    <a:satMod val="160000"/>
                  </a:schemeClr>
                </a:gs>
                <a:gs pos="50000">
                  <a:schemeClr val="accent1">
                    <a:tint val="44500"/>
                    <a:satMod val="160000"/>
                  </a:schemeClr>
                </a:gs>
                <a:gs pos="100000">
                  <a:schemeClr val="accent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709623" y="2661916"/>
              <a:ext cx="2447619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638 COVID-19 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tentially</a:t>
              </a:r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ligible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Connettore 2 9"/>
            <p:cNvCxnSpPr/>
            <p:nvPr/>
          </p:nvCxnSpPr>
          <p:spPr>
            <a:xfrm>
              <a:off x="3291840" y="3580467"/>
              <a:ext cx="0" cy="72000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CasellaDiTesto 10"/>
            <p:cNvSpPr txBox="1"/>
            <p:nvPr/>
          </p:nvSpPr>
          <p:spPr>
            <a:xfrm>
              <a:off x="2140771" y="4300467"/>
              <a:ext cx="2302137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49 </a:t>
              </a:r>
              <a:r>
                <a:rPr lang="it-IT" sz="1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cluded</a:t>
              </a: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it-IT" sz="1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ge</a:t>
              </a: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&gt;90, cognitive </a:t>
              </a:r>
              <a:r>
                <a:rPr lang="it-IT" sz="1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mpairment</a:t>
              </a: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3454999" y="2795637"/>
              <a:ext cx="230213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589 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hone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lls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Connettore 2 12"/>
            <p:cNvCxnSpPr/>
            <p:nvPr/>
          </p:nvCxnSpPr>
          <p:spPr>
            <a:xfrm>
              <a:off x="5737413" y="3580467"/>
              <a:ext cx="0" cy="72000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CasellaDiTesto 13"/>
            <p:cNvSpPr txBox="1"/>
            <p:nvPr/>
          </p:nvSpPr>
          <p:spPr>
            <a:xfrm>
              <a:off x="4776396" y="4300467"/>
              <a:ext cx="263562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buFont typeface="Wingdings" panose="05000000000000000000" pitchFamily="2" charset="2"/>
                <a:buChar char="§"/>
              </a:pPr>
              <a:r>
                <a:rPr lang="it-IT" sz="1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ot</a:t>
              </a: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achable</a:t>
              </a: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: 55</a:t>
              </a:r>
            </a:p>
            <a:p>
              <a:pPr marL="285750" indent="-285750">
                <a:buFont typeface="Wingdings" panose="05000000000000000000" pitchFamily="2" charset="2"/>
                <a:buChar char="§"/>
              </a:pP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Dead: 23</a:t>
              </a:r>
            </a:p>
            <a:p>
              <a:pPr marL="285750" indent="-285750">
                <a:buFont typeface="Wingdings" panose="05000000000000000000" pitchFamily="2" charset="2"/>
                <a:buChar char="§"/>
              </a:pPr>
              <a:r>
                <a:rPr lang="it-IT" sz="1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fused</a:t>
              </a: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ticipation</a:t>
              </a:r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: 406</a:t>
              </a: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5994329" y="2795636"/>
              <a:ext cx="230213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105 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ned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interviews</a:t>
              </a: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8477021" y="2795636"/>
              <a:ext cx="230213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98 in-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erson</a:t>
              </a:r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terviews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Connettore 2 16"/>
            <p:cNvCxnSpPr/>
            <p:nvPr/>
          </p:nvCxnSpPr>
          <p:spPr>
            <a:xfrm>
              <a:off x="8202707" y="3580467"/>
              <a:ext cx="0" cy="72000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CasellaDiTesto 17"/>
            <p:cNvSpPr txBox="1"/>
            <p:nvPr/>
          </p:nvSpPr>
          <p:spPr>
            <a:xfrm>
              <a:off x="7031919" y="4300466"/>
              <a:ext cx="230213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7 no show</a:t>
              </a:r>
            </a:p>
          </p:txBody>
        </p:sp>
      </p:grpSp>
      <p:sp>
        <p:nvSpPr>
          <p:cNvPr id="19" name="Rettangolo 18"/>
          <p:cNvSpPr/>
          <p:nvPr/>
        </p:nvSpPr>
        <p:spPr>
          <a:xfrm>
            <a:off x="350536" y="5460004"/>
            <a:ext cx="28376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7. </a:t>
            </a:r>
            <a:r>
              <a:rPr lang="en-US" sz="1200" b="1" dirty="0">
                <a:latin typeface="Palatino Linotype" panose="02040502050505030304" pitchFamily="18" charset="0"/>
              </a:rPr>
              <a:t>Patient selection flowchart.</a:t>
            </a:r>
            <a:endParaRPr lang="en-GB" sz="12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55841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987808"/>
              </p:ext>
            </p:extLst>
          </p:nvPr>
        </p:nvGraphicFramePr>
        <p:xfrm>
          <a:off x="1403349" y="812143"/>
          <a:ext cx="9137651" cy="4706631"/>
        </p:xfrm>
        <a:graphic>
          <a:graphicData uri="http://schemas.openxmlformats.org/drawingml/2006/table">
            <a:tbl>
              <a:tblPr/>
              <a:tblGrid>
                <a:gridCol w="13063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3216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890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92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8373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8373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8373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43252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 </a:t>
                      </a:r>
                      <a:r>
                        <a:rPr lang="it-IT" sz="1100" b="1" i="0" u="none" strike="noStrike" dirty="0" err="1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s</a:t>
                      </a:r>
                      <a:endParaRPr lang="it-IT" sz="1100" b="1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S </a:t>
                      </a:r>
                    </a:p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48)</a:t>
                      </a:r>
                    </a:p>
                  </a:txBody>
                  <a:tcPr marL="8250" marR="8250" marT="82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O MPS </a:t>
                      </a:r>
                    </a:p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50)</a:t>
                      </a:r>
                    </a:p>
                  </a:txBody>
                  <a:tcPr marL="8250" marR="8250" marT="82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100" b="1" i="1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</a:t>
                      </a:r>
                      <a:r>
                        <a:rPr lang="it-IT" sz="1100" b="1" i="1" u="none" strike="noStrike" dirty="0" err="1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it-IT" sz="1100" b="1" i="1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S </a:t>
                      </a:r>
                    </a:p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39)</a:t>
                      </a:r>
                    </a:p>
                  </a:txBody>
                  <a:tcPr marL="8250" marR="8250" marT="82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NS </a:t>
                      </a:r>
                    </a:p>
                    <a:p>
                      <a:pPr algn="ctr" rtl="0" fontAlgn="ctr"/>
                      <a:r>
                        <a:rPr lang="it-IT" sz="1100" b="1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59)</a:t>
                      </a:r>
                    </a:p>
                  </a:txBody>
                  <a:tcPr marL="8250" marR="8250" marT="82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100" b="1" i="1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</a:t>
                      </a:r>
                      <a:r>
                        <a:rPr lang="it-IT" sz="1100" b="1" i="1" u="none" strike="noStrike" dirty="0" err="1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it-IT" sz="1100" b="1" i="1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emoglobin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-18 g/</a:t>
                      </a:r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4 ± 1.80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45 ± 4.87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55 ± 1.73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0 ±</a:t>
                      </a:r>
                      <a:r>
                        <a:rPr lang="it-IT" sz="11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.42</a:t>
                      </a:r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ematocrit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-53 %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7 ± 4.78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2 ± 6.8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4 ± 4.89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20 ± 6.41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 blood cells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0-5.90 10^12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4 ± 0.66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8 ± 0.66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5 ± 0.68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5 ± 0.73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 blood cells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0-11.30 10^9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0 ± 2.37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0 ± 1.65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7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5 ± 2.16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4 ± 2.19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ophils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-8.00 10^9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1 ± 1.42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3 ± 1.26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1 ± 1.32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5 ± 1.44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ocyte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4.80 10^9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6 ± 1.68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6 ± 0.75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5 ± 1.72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 ± 0.98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cyte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-1 10^9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 ± 0.13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 ± 0.11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 ± 0.13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 ±</a:t>
                      </a:r>
                      <a:r>
                        <a:rPr lang="it-IT" sz="11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0.13</a:t>
                      </a:r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osinophil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0.80 10^9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 ± 0.15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 ± 0.13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 ± 0.15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 ± 0.15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ophil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0.20 10^9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 0.02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 ± 0.0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 0.02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 ± 0.0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elet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-400 10^9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.0 ± 59.03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6.5 ± 65.0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.0 ±</a:t>
                      </a:r>
                      <a:r>
                        <a:rPr lang="it-IT" sz="11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70.22</a:t>
                      </a:r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.0 ± 56.15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ilirubin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-1.20 mg/</a:t>
                      </a:r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 ± 0.41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 ± 0.5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 ± 0.45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 ± 0.46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T/ALT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-40 U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 ± 18.49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5 ± 12.64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0 ± 13.24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0 ± 17.30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atinine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-1.10 mg/</a:t>
                      </a:r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 ± 0.39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 ± 1.51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 ± 0.43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 ± 1.35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-145 </a:t>
                      </a:r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</a:t>
                      </a:r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.0 ± 2.30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.0 ±</a:t>
                      </a:r>
                      <a:r>
                        <a:rPr lang="it-IT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88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.0 ± 2.13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.0 ± 2.08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assium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0-5.10 </a:t>
                      </a:r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</a:t>
                      </a:r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4 ± 0.45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1 ± 0.79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1 ± 0.49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4 ± 0.7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H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-246 U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.0 ± 35.2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.0 ±</a:t>
                      </a:r>
                      <a:r>
                        <a:rPr lang="it-IT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0.86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.0 ± 37.81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.5 ± 46.73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P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 mg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 ± 1.16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 ± 2.8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 ± 1.94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 ± 2.3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R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 ± 0.11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 ± 0.44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 ± 0.10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 ± 0.40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TT</a:t>
                      </a:r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1-37.7 sec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90 ± 5.63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0 ± 8.56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25 ± 4.42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70 ± 8.45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0745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-dimer 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50.00 </a:t>
                      </a:r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g</a:t>
                      </a:r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2.0 ± 347.9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.0 ±</a:t>
                      </a:r>
                      <a:r>
                        <a:rPr lang="it-IT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74.85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0.0 ± 476.1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.0 ± 341.2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14061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rinogen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-420 mg/</a:t>
                      </a:r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5.0 ± 64.79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1 ± 62.03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5.0 ± 59.7</a:t>
                      </a:r>
                    </a:p>
                  </a:txBody>
                  <a:tcPr marL="8250" marR="8250" marT="825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.0 ± 65.74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L="8250" marR="8250" marT="82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5" name="CasellaDiTesto 4"/>
          <p:cNvSpPr txBox="1"/>
          <p:nvPr/>
        </p:nvSpPr>
        <p:spPr>
          <a:xfrm>
            <a:off x="1403349" y="5667395"/>
            <a:ext cx="91376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</a:rPr>
              <a:t>Values are expressed as median ± SD. </a:t>
            </a:r>
          </a:p>
          <a:p>
            <a:pPr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MPS: Major physical symptoms; MNS: Major neuropsychological symptoms.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</a:rPr>
              <a:t>GPT/ ALT: alanine aminotransferase; LDH: Lactate dehydrogenase; CRP: c-reactive protein; INR: international normalised ratio; </a:t>
            </a:r>
            <a:r>
              <a:rPr lang="en-GB" sz="1200" dirty="0" err="1">
                <a:solidFill>
                  <a:srgbClr val="000000"/>
                </a:solidFill>
                <a:latin typeface="Arial" panose="020B0604020202020204" pitchFamily="34" charset="0"/>
              </a:rPr>
              <a:t>aPTT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</a:rPr>
              <a:t>: Activated Partial Thromboplastin Time.  </a:t>
            </a: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103908" y="-6478"/>
            <a:ext cx="12088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  <a:cs typeface="Arial" panose="020B0604020202020204" pitchFamily="34" charset="0"/>
              </a:rPr>
              <a:t>Table S1</a:t>
            </a:r>
            <a:r>
              <a:rPr lang="en-GB" dirty="0">
                <a:latin typeface="Palatino Linotype" panose="02040502050505030304" pitchFamily="18" charset="0"/>
                <a:cs typeface="Arial" panose="020B0604020202020204" pitchFamily="34" charset="0"/>
              </a:rPr>
              <a:t>. Haematological tests and their respective reference values for LONG COVID patients at follow-up  </a:t>
            </a:r>
          </a:p>
        </p:txBody>
      </p:sp>
    </p:spTree>
    <p:extLst>
      <p:ext uri="{BB962C8B-B14F-4D97-AF65-F5344CB8AC3E}">
        <p14:creationId xmlns:p14="http://schemas.microsoft.com/office/powerpoint/2010/main" val="561410139"/>
      </p:ext>
    </p:extLst>
  </p:cSld>
  <p:clrMapOvr>
    <a:masterClrMapping/>
  </p:clrMapOvr>
  <p:extLst>
    <p:ext uri="{6950BFC3-D8DA-4A85-94F7-54DA5524770B}">
      <p188:commentRel xmlns="" xmlns:p188="http://schemas.microsoft.com/office/powerpoint/2018/8/main" r:id="rId2"/>
    </p:ext>
  </p:extLs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03908" y="-6478"/>
            <a:ext cx="120880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  <a:cs typeface="Arial" panose="020B0604020202020204" pitchFamily="34" charset="0"/>
              </a:rPr>
              <a:t>Table S2</a:t>
            </a:r>
            <a:r>
              <a:rPr lang="en-GB" dirty="0">
                <a:latin typeface="Palatino Linotype" panose="02040502050505030304" pitchFamily="18" charset="0"/>
                <a:cs typeface="Arial" panose="020B0604020202020204" pitchFamily="34" charset="0"/>
              </a:rPr>
              <a:t>. Comparison between univariate and </a:t>
            </a:r>
            <a:r>
              <a:rPr lang="en-US" dirty="0">
                <a:latin typeface="Palatino Linotype" panose="02040502050505030304" pitchFamily="18" charset="0"/>
              </a:rPr>
              <a:t>multiple logistic regression in major physical symptoms (MPS) </a:t>
            </a:r>
            <a:r>
              <a:rPr lang="en-US" i="1" dirty="0">
                <a:latin typeface="Palatino Linotype" panose="02040502050505030304" pitchFamily="18" charset="0"/>
              </a:rPr>
              <a:t>vs</a:t>
            </a:r>
            <a:r>
              <a:rPr lang="en-US" dirty="0">
                <a:latin typeface="Palatino Linotype" panose="02040502050505030304" pitchFamily="18" charset="0"/>
              </a:rPr>
              <a:t> no MPS patients</a:t>
            </a:r>
            <a:endParaRPr lang="en-GB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el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6081375"/>
              </p:ext>
            </p:extLst>
          </p:nvPr>
        </p:nvGraphicFramePr>
        <p:xfrm>
          <a:off x="1889760" y="1235033"/>
          <a:ext cx="8837466" cy="415863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381209">
                  <a:extLst>
                    <a:ext uri="{9D8B030D-6E8A-4147-A177-3AD203B41FA5}">
                      <a16:colId xmlns:a16="http://schemas.microsoft.com/office/drawing/2014/main" val="3897268005"/>
                    </a:ext>
                  </a:extLst>
                </a:gridCol>
                <a:gridCol w="1718396">
                  <a:extLst>
                    <a:ext uri="{9D8B030D-6E8A-4147-A177-3AD203B41FA5}">
                      <a16:colId xmlns:a16="http://schemas.microsoft.com/office/drawing/2014/main" val="100197737"/>
                    </a:ext>
                  </a:extLst>
                </a:gridCol>
                <a:gridCol w="1012049">
                  <a:extLst>
                    <a:ext uri="{9D8B030D-6E8A-4147-A177-3AD203B41FA5}">
                      <a16:colId xmlns:a16="http://schemas.microsoft.com/office/drawing/2014/main" val="2292008365"/>
                    </a:ext>
                  </a:extLst>
                </a:gridCol>
                <a:gridCol w="1720713">
                  <a:extLst>
                    <a:ext uri="{9D8B030D-6E8A-4147-A177-3AD203B41FA5}">
                      <a16:colId xmlns:a16="http://schemas.microsoft.com/office/drawing/2014/main" val="697737284"/>
                    </a:ext>
                  </a:extLst>
                </a:gridCol>
                <a:gridCol w="1005099">
                  <a:extLst>
                    <a:ext uri="{9D8B030D-6E8A-4147-A177-3AD203B41FA5}">
                      <a16:colId xmlns:a16="http://schemas.microsoft.com/office/drawing/2014/main" val="3747996953"/>
                    </a:ext>
                  </a:extLst>
                </a:gridCol>
              </a:tblGrid>
              <a:tr h="49437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it-IT" sz="14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MPS</a:t>
                      </a:r>
                      <a:endParaRPr lang="it-IT" sz="14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it-IT" sz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AEDF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2691710"/>
                  </a:ext>
                </a:extLst>
              </a:tr>
              <a:tr h="48370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Univariate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Multivariate, 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adjusted for age and former smoking habit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3534968"/>
                  </a:ext>
                </a:extLst>
              </a:tr>
              <a:tr h="634719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it-IT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OR(95%CI)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p value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OR(95%CI)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i="1" dirty="0"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 value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50724052"/>
                  </a:ext>
                </a:extLst>
              </a:tr>
              <a:tr h="634719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LEF1-AS1 multiple isoforms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73 (0.56-0.93)</a:t>
                      </a:r>
                      <a:endParaRPr lang="it-IT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01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75 (0.56-1.00)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05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36206809"/>
                  </a:ext>
                </a:extLst>
              </a:tr>
              <a:tr h="634719"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LEF1–AS1–202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71 (0.52-0.97)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03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80 (0.56-1.13)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21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52211758"/>
                  </a:ext>
                </a:extLst>
              </a:tr>
              <a:tr h="634719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LEF1–AS1–207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73 (0.59-1.00)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05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84 (0.58-1.20)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33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40659606"/>
                  </a:ext>
                </a:extLst>
              </a:tr>
              <a:tr h="634719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LEF1</a:t>
                      </a:r>
                      <a:endParaRPr lang="it-IT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66 (0.46-0.95)</a:t>
                      </a:r>
                      <a:endParaRPr lang="it-IT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03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68 (0.46-1.02)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06</a:t>
                      </a:r>
                      <a:endParaRPr lang="it-IT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207259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965855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08</TotalTime>
  <Words>1524</Words>
  <Application>Microsoft Macintosh PowerPoint</Application>
  <PresentationFormat>Widescreen</PresentationFormat>
  <Paragraphs>361</Paragraphs>
  <Slides>1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6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Palatino Linotype</vt:lpstr>
      <vt:lpstr>Times New Roman</vt:lpstr>
      <vt:lpstr>Wingdings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Policlinico San Dona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isia Madè</dc:creator>
  <cp:lastModifiedBy>Alisia Madè</cp:lastModifiedBy>
  <cp:revision>192</cp:revision>
  <dcterms:created xsi:type="dcterms:W3CDTF">2024-02-07T09:07:57Z</dcterms:created>
  <dcterms:modified xsi:type="dcterms:W3CDTF">2025-05-16T16:05:27Z</dcterms:modified>
</cp:coreProperties>
</file>